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0" r:id="rId2"/>
  </p:sldIdLst>
  <p:sldSz cx="9144000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032"/>
    <p:restoredTop sz="94648"/>
  </p:normalViewPr>
  <p:slideViewPr>
    <p:cSldViewPr snapToGrid="0">
      <p:cViewPr varScale="1">
        <p:scale>
          <a:sx n="53" d="100"/>
          <a:sy n="53" d="100"/>
        </p:scale>
        <p:origin x="73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76CC82-E787-D040-9406-E6C8F2F29A69}" type="datetimeFigureOut">
              <a:rPr lang="en-US" smtClean="0"/>
              <a:t>7/1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E58DD9-2B26-3342-8F72-4A3BFDD476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705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6" name="Google Shape;656;p1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57" name="Google Shape;657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356703"/>
            <a:ext cx="7772400" cy="501340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7563446"/>
            <a:ext cx="6858000" cy="347671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891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2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766678"/>
            <a:ext cx="1971675" cy="122035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766678"/>
            <a:ext cx="5800725" cy="1220351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269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276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590057"/>
            <a:ext cx="7886700" cy="5990088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9636813"/>
            <a:ext cx="7886700" cy="315004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253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833390"/>
            <a:ext cx="3886200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833390"/>
            <a:ext cx="3886200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84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66681"/>
            <a:ext cx="7886700" cy="27833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530053"/>
            <a:ext cx="3868340" cy="17300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5260078"/>
            <a:ext cx="3868340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530053"/>
            <a:ext cx="3887391" cy="17300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5260078"/>
            <a:ext cx="3887391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032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034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93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60014"/>
            <a:ext cx="2949178" cy="33600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2073367"/>
            <a:ext cx="4629150" cy="1023348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320064"/>
            <a:ext cx="2949178" cy="80034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618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60014"/>
            <a:ext cx="2949178" cy="33600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2073367"/>
            <a:ext cx="4629150" cy="1023348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320064"/>
            <a:ext cx="2949178" cy="80034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644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766681"/>
            <a:ext cx="788670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833390"/>
            <a:ext cx="788670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3346867"/>
            <a:ext cx="20574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3346867"/>
            <a:ext cx="30861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3346867"/>
            <a:ext cx="20574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226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9" name="Google Shape;659;p27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75932" y="4856692"/>
            <a:ext cx="2116392" cy="2648737"/>
          </a:xfrm>
          <a:prstGeom prst="rect">
            <a:avLst/>
          </a:prstGeom>
          <a:noFill/>
          <a:ln>
            <a:noFill/>
          </a:ln>
        </p:spPr>
      </p:pic>
      <p:pic>
        <p:nvPicPr>
          <p:cNvPr id="660" name="Google Shape;660;p27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2392323" y="4597010"/>
            <a:ext cx="2116392" cy="2908417"/>
          </a:xfrm>
          <a:prstGeom prst="rect">
            <a:avLst/>
          </a:prstGeom>
          <a:noFill/>
          <a:ln>
            <a:noFill/>
          </a:ln>
        </p:spPr>
      </p:pic>
      <p:pic>
        <p:nvPicPr>
          <p:cNvPr id="661" name="Google Shape;661;p27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4571999" y="4856690"/>
            <a:ext cx="2116392" cy="2648737"/>
          </a:xfrm>
          <a:prstGeom prst="rect">
            <a:avLst/>
          </a:prstGeom>
          <a:noFill/>
          <a:ln>
            <a:noFill/>
          </a:ln>
        </p:spPr>
      </p:pic>
      <p:pic>
        <p:nvPicPr>
          <p:cNvPr id="662" name="Google Shape;662;p27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6751675" y="4856690"/>
            <a:ext cx="2116392" cy="2648737"/>
          </a:xfrm>
          <a:prstGeom prst="rect">
            <a:avLst/>
          </a:prstGeom>
          <a:noFill/>
          <a:ln>
            <a:noFill/>
          </a:ln>
        </p:spPr>
      </p:pic>
      <p:pic>
        <p:nvPicPr>
          <p:cNvPr id="663" name="Google Shape;663;p27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275932" y="1712780"/>
            <a:ext cx="1943232" cy="2648737"/>
          </a:xfrm>
          <a:prstGeom prst="rect">
            <a:avLst/>
          </a:prstGeom>
          <a:noFill/>
          <a:ln>
            <a:noFill/>
          </a:ln>
        </p:spPr>
      </p:pic>
      <p:pic>
        <p:nvPicPr>
          <p:cNvPr id="664" name="Google Shape;664;p27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4571999" y="1836552"/>
            <a:ext cx="2029874" cy="2524965"/>
          </a:xfrm>
          <a:prstGeom prst="rect">
            <a:avLst/>
          </a:prstGeom>
          <a:noFill/>
          <a:ln>
            <a:noFill/>
          </a:ln>
        </p:spPr>
      </p:pic>
      <p:pic>
        <p:nvPicPr>
          <p:cNvPr id="665" name="Google Shape;665;p27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6751675" y="1836552"/>
            <a:ext cx="2017496" cy="2524964"/>
          </a:xfrm>
          <a:prstGeom prst="rect">
            <a:avLst/>
          </a:prstGeom>
          <a:noFill/>
          <a:ln>
            <a:noFill/>
          </a:ln>
        </p:spPr>
      </p:pic>
      <p:pic>
        <p:nvPicPr>
          <p:cNvPr id="666" name="Google Shape;666;p27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2392323" y="1531229"/>
            <a:ext cx="2017495" cy="285915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1F59E4E-D562-6DA4-8832-5FADB64FD24A}"/>
              </a:ext>
            </a:extLst>
          </p:cNvPr>
          <p:cNvSpPr txBox="1"/>
          <p:nvPr/>
        </p:nvSpPr>
        <p:spPr>
          <a:xfrm>
            <a:off x="577516" y="8048289"/>
            <a:ext cx="7988968" cy="13409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CA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. 4 Lymphocytes flow cytometry analyses in FC1199 tumor model. 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hown are the lymphocytes flow cytometry analysis of lymphocytes in FC1199 pancreatic liver metastasis model at Day 8 post-tumor injection in SHAM-control, OVX, and OVX + E2 mice (n=4).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48</Words>
  <Application>Microsoft Macintosh PowerPoint</Application>
  <PresentationFormat>Custom</PresentationFormat>
  <Paragraphs>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smine Benslimane (CUSM)</dc:creator>
  <cp:lastModifiedBy>Yasmine Benslimane (CUSM)</cp:lastModifiedBy>
  <cp:revision>10</cp:revision>
  <dcterms:created xsi:type="dcterms:W3CDTF">2024-06-04T23:51:01Z</dcterms:created>
  <dcterms:modified xsi:type="dcterms:W3CDTF">2024-07-10T15:11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6a7d8d5d-78e2-4a62-9fcd-016eb5e4c57c_Enabled">
    <vt:lpwstr>true</vt:lpwstr>
  </property>
  <property fmtid="{D5CDD505-2E9C-101B-9397-08002B2CF9AE}" pid="3" name="MSIP_Label_6a7d8d5d-78e2-4a62-9fcd-016eb5e4c57c_SetDate">
    <vt:lpwstr>2024-06-04T23:52:34Z</vt:lpwstr>
  </property>
  <property fmtid="{D5CDD505-2E9C-101B-9397-08002B2CF9AE}" pid="4" name="MSIP_Label_6a7d8d5d-78e2-4a62-9fcd-016eb5e4c57c_Method">
    <vt:lpwstr>Standard</vt:lpwstr>
  </property>
  <property fmtid="{D5CDD505-2E9C-101B-9397-08002B2CF9AE}" pid="5" name="MSIP_Label_6a7d8d5d-78e2-4a62-9fcd-016eb5e4c57c_Name">
    <vt:lpwstr>Général</vt:lpwstr>
  </property>
  <property fmtid="{D5CDD505-2E9C-101B-9397-08002B2CF9AE}" pid="6" name="MSIP_Label_6a7d8d5d-78e2-4a62-9fcd-016eb5e4c57c_SiteId">
    <vt:lpwstr>06e1fe28-5f8b-4075-bf6c-ae24be1a7992</vt:lpwstr>
  </property>
  <property fmtid="{D5CDD505-2E9C-101B-9397-08002B2CF9AE}" pid="7" name="MSIP_Label_6a7d8d5d-78e2-4a62-9fcd-016eb5e4c57c_ActionId">
    <vt:lpwstr>7787e28e-b149-4962-94cc-d172c1dcb2b1</vt:lpwstr>
  </property>
  <property fmtid="{D5CDD505-2E9C-101B-9397-08002B2CF9AE}" pid="8" name="MSIP_Label_6a7d8d5d-78e2-4a62-9fcd-016eb5e4c57c_ContentBits">
    <vt:lpwstr>0</vt:lpwstr>
  </property>
</Properties>
</file>